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 varScale="1">
        <p:scale>
          <a:sx n="56" d="100"/>
          <a:sy n="56" d="100"/>
        </p:scale>
        <p:origin x="-2400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6Jun20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6Jun2015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6Jun2015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6Jun20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93318392860549"/>
          <c:y val="0.0756860336117504"/>
          <c:w val="0.387356989356296"/>
          <c:h val="0.66768238454556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BON_26Jun15!$K$19</c:f>
              <c:strCache>
                <c:ptCount val="1"/>
                <c:pt idx="0">
                  <c:v>LI</c:v>
                </c:pt>
              </c:strCache>
            </c:strRef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BON_26Jun15!$N$20:$N$21</c:f>
                <c:numCache>
                  <c:formatCode>General</c:formatCode>
                  <c:ptCount val="2"/>
                  <c:pt idx="0">
                    <c:v>0.077985426781178</c:v>
                  </c:pt>
                  <c:pt idx="1">
                    <c:v>0.07441218202937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MBON_26Jun15!$J$20:$J$21</c:f>
              <c:strCache>
                <c:ptCount val="2"/>
                <c:pt idx="0">
                  <c:v>MB093C</c:v>
                </c:pt>
                <c:pt idx="1">
                  <c:v>MB082C</c:v>
                </c:pt>
              </c:strCache>
            </c:strRef>
          </c:cat>
          <c:val>
            <c:numRef>
              <c:f>MBON_26Jun15!$K$20:$K$21</c:f>
              <c:numCache>
                <c:formatCode>General</c:formatCode>
                <c:ptCount val="2"/>
                <c:pt idx="0">
                  <c:v>0.148691296296296</c:v>
                </c:pt>
                <c:pt idx="1">
                  <c:v>0.10149</c:v>
                </c:pt>
              </c:numCache>
            </c:numRef>
          </c:val>
        </c:ser>
        <c:ser>
          <c:idx val="1"/>
          <c:order val="1"/>
          <c:tx>
            <c:strRef>
              <c:f>MBON_26Jun15!$L$19</c:f>
              <c:strCache>
                <c:ptCount val="1"/>
                <c:pt idx="0">
                  <c:v>MI</c:v>
                </c:pt>
              </c:strCache>
            </c:strRef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MBON_26Jun15!$O$20:$O$21</c:f>
                <c:numCache>
                  <c:formatCode>General</c:formatCode>
                  <c:ptCount val="2"/>
                  <c:pt idx="0">
                    <c:v>0.0851908899804271</c:v>
                  </c:pt>
                  <c:pt idx="1">
                    <c:v>0.0789265718450755</c:v>
                  </c:pt>
                </c:numCache>
              </c:numRef>
            </c:minus>
          </c:errBars>
          <c:cat>
            <c:strRef>
              <c:f>MBON_26Jun15!$J$20:$J$21</c:f>
              <c:strCache>
                <c:ptCount val="2"/>
                <c:pt idx="0">
                  <c:v>MB093C</c:v>
                </c:pt>
                <c:pt idx="1">
                  <c:v>MB082C</c:v>
                </c:pt>
              </c:strCache>
            </c:strRef>
          </c:cat>
          <c:val>
            <c:numRef>
              <c:f>MBON_26Jun15!$L$20:$L$21</c:f>
              <c:numCache>
                <c:formatCode>General</c:formatCode>
                <c:ptCount val="2"/>
                <c:pt idx="0">
                  <c:v>-0.173489444444444</c:v>
                </c:pt>
                <c:pt idx="1">
                  <c:v>-0.1105192105263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8731944"/>
        <c:axId val="-2117913736"/>
      </c:barChart>
      <c:catAx>
        <c:axId val="-2128731944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17913736"/>
        <c:crosses val="autoZero"/>
        <c:auto val="1"/>
        <c:lblAlgn val="ctr"/>
        <c:lblOffset val="100"/>
        <c:noMultiLvlLbl val="0"/>
      </c:catAx>
      <c:valAx>
        <c:axId val="-2117913736"/>
        <c:scaling>
          <c:orientation val="minMax"/>
          <c:min val="-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2873194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21412684573854"/>
          <c:y val="0.401924928256425"/>
          <c:w val="0.232220231236665"/>
          <c:h val="0.1961501434871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72759984129373"/>
          <c:y val="0.0756860336117504"/>
          <c:w val="0.398128041828886"/>
          <c:h val="0.668260000550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BON_26Jun15!$K$22</c:f>
              <c:strCache>
                <c:ptCount val="1"/>
                <c:pt idx="0">
                  <c:v>LI</c:v>
                </c:pt>
              </c:strCache>
            </c:strRef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BON_26Jun15!$N$23:$N$24</c:f>
                <c:numCache>
                  <c:formatCode>General</c:formatCode>
                  <c:ptCount val="2"/>
                  <c:pt idx="0">
                    <c:v>0.0702912151514612</c:v>
                  </c:pt>
                  <c:pt idx="1">
                    <c:v>0.06058230284048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MBON_26Jun15!$J$23:$J$24</c:f>
              <c:strCache>
                <c:ptCount val="2"/>
                <c:pt idx="0">
                  <c:v>MB074C</c:v>
                </c:pt>
                <c:pt idx="1">
                  <c:v>MB399B</c:v>
                </c:pt>
              </c:strCache>
            </c:strRef>
          </c:cat>
          <c:val>
            <c:numRef>
              <c:f>MBON_26Jun15!$K$23:$K$24</c:f>
              <c:numCache>
                <c:formatCode>General</c:formatCode>
                <c:ptCount val="2"/>
                <c:pt idx="0">
                  <c:v>0.226104803921569</c:v>
                </c:pt>
                <c:pt idx="1">
                  <c:v>0.250154015151515</c:v>
                </c:pt>
              </c:numCache>
            </c:numRef>
          </c:val>
        </c:ser>
        <c:ser>
          <c:idx val="1"/>
          <c:order val="1"/>
          <c:tx>
            <c:strRef>
              <c:f>MBON_26Jun15!$L$22</c:f>
              <c:strCache>
                <c:ptCount val="1"/>
                <c:pt idx="0">
                  <c:v>MI</c:v>
                </c:pt>
              </c:strCache>
            </c:strRef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MBON_26Jun15!$O$23:$O$24</c:f>
                <c:numCache>
                  <c:formatCode>General</c:formatCode>
                  <c:ptCount val="2"/>
                  <c:pt idx="0">
                    <c:v>0.122834941826343</c:v>
                  </c:pt>
                  <c:pt idx="1">
                    <c:v>0.0808102686653942</c:v>
                  </c:pt>
                </c:numCache>
              </c:numRef>
            </c:minus>
          </c:errBars>
          <c:cat>
            <c:strRef>
              <c:f>MBON_26Jun15!$J$23:$J$24</c:f>
              <c:strCache>
                <c:ptCount val="2"/>
                <c:pt idx="0">
                  <c:v>MB074C</c:v>
                </c:pt>
                <c:pt idx="1">
                  <c:v>MB399B</c:v>
                </c:pt>
              </c:strCache>
            </c:strRef>
          </c:cat>
          <c:val>
            <c:numRef>
              <c:f>MBON_26Jun15!$L$23:$L$24</c:f>
              <c:numCache>
                <c:formatCode>General</c:formatCode>
                <c:ptCount val="2"/>
                <c:pt idx="0">
                  <c:v>-0.167659705882353</c:v>
                </c:pt>
                <c:pt idx="1">
                  <c:v>-0.1904443181818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1148408"/>
        <c:axId val="-2101145400"/>
      </c:barChart>
      <c:catAx>
        <c:axId val="-2101148408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01145400"/>
        <c:crosses val="autoZero"/>
        <c:auto val="1"/>
        <c:lblAlgn val="ctr"/>
        <c:lblOffset val="100"/>
        <c:noMultiLvlLbl val="0"/>
      </c:catAx>
      <c:valAx>
        <c:axId val="-2101145400"/>
        <c:scaling>
          <c:orientation val="minMax"/>
          <c:min val="-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011484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10971339587616"/>
          <c:y val="0.401924928256425"/>
          <c:w val="0.233162410958583"/>
          <c:h val="0.1961501434871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97376879363879"/>
          <c:y val="0.0756860336117504"/>
          <c:w val="0.520467291212859"/>
          <c:h val="0.6662420119373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BON_26Jun15!$K$13</c:f>
              <c:strCache>
                <c:ptCount val="1"/>
                <c:pt idx="0">
                  <c:v>LI</c:v>
                </c:pt>
              </c:strCache>
            </c:strRef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BON_26Jun15!$N$14:$N$18</c:f>
                <c:numCache>
                  <c:formatCode>General</c:formatCode>
                  <c:ptCount val="5"/>
                  <c:pt idx="0">
                    <c:v>0.0496463112720916</c:v>
                  </c:pt>
                  <c:pt idx="1">
                    <c:v>0.0544926378896368</c:v>
                  </c:pt>
                  <c:pt idx="2">
                    <c:v>0.0488286004896467</c:v>
                  </c:pt>
                  <c:pt idx="3">
                    <c:v>0.060553341817256</c:v>
                  </c:pt>
                  <c:pt idx="4">
                    <c:v>0.0561449067086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MBON_26Jun15!$J$14:$J$18</c:f>
              <c:strCache>
                <c:ptCount val="5"/>
                <c:pt idx="0">
                  <c:v>MB057B</c:v>
                </c:pt>
                <c:pt idx="1">
                  <c:v>MB549C</c:v>
                </c:pt>
                <c:pt idx="2">
                  <c:v>MB543B</c:v>
                </c:pt>
                <c:pt idx="3">
                  <c:v>MB027B</c:v>
                </c:pt>
                <c:pt idx="4">
                  <c:v>MB242A</c:v>
                </c:pt>
              </c:strCache>
            </c:strRef>
          </c:cat>
          <c:val>
            <c:numRef>
              <c:f>MBON_26Jun15!$K$14:$K$18</c:f>
              <c:numCache>
                <c:formatCode>General</c:formatCode>
                <c:ptCount val="5"/>
                <c:pt idx="0">
                  <c:v>0.266024924242424</c:v>
                </c:pt>
                <c:pt idx="1">
                  <c:v>0.103510555555556</c:v>
                </c:pt>
                <c:pt idx="2">
                  <c:v>0.130857348484849</c:v>
                </c:pt>
                <c:pt idx="3">
                  <c:v>0.282937727272727</c:v>
                </c:pt>
                <c:pt idx="4">
                  <c:v>0.244396041666667</c:v>
                </c:pt>
              </c:numCache>
            </c:numRef>
          </c:val>
        </c:ser>
        <c:ser>
          <c:idx val="1"/>
          <c:order val="1"/>
          <c:tx>
            <c:strRef>
              <c:f>MBON_26Jun15!$L$13</c:f>
              <c:strCache>
                <c:ptCount val="1"/>
                <c:pt idx="0">
                  <c:v>MI</c:v>
                </c:pt>
              </c:strCache>
            </c:strRef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MBON_26Jun15!$O$14:$O$18</c:f>
                <c:numCache>
                  <c:formatCode>General</c:formatCode>
                  <c:ptCount val="5"/>
                  <c:pt idx="0">
                    <c:v>0.0939940553419682</c:v>
                  </c:pt>
                  <c:pt idx="1">
                    <c:v>0.103971111386523</c:v>
                  </c:pt>
                  <c:pt idx="2">
                    <c:v>0.0854606153985101</c:v>
                  </c:pt>
                  <c:pt idx="3">
                    <c:v>0.0866362771052046</c:v>
                  </c:pt>
                  <c:pt idx="4">
                    <c:v>0.0769781735686476</c:v>
                  </c:pt>
                </c:numCache>
              </c:numRef>
            </c:minus>
          </c:errBars>
          <c:cat>
            <c:strRef>
              <c:f>MBON_26Jun15!$J$14:$J$18</c:f>
              <c:strCache>
                <c:ptCount val="5"/>
                <c:pt idx="0">
                  <c:v>MB057B</c:v>
                </c:pt>
                <c:pt idx="1">
                  <c:v>MB549C</c:v>
                </c:pt>
                <c:pt idx="2">
                  <c:v>MB543B</c:v>
                </c:pt>
                <c:pt idx="3">
                  <c:v>MB027B</c:v>
                </c:pt>
                <c:pt idx="4">
                  <c:v>MB242A</c:v>
                </c:pt>
              </c:strCache>
            </c:strRef>
          </c:cat>
          <c:val>
            <c:numRef>
              <c:f>MBON_26Jun15!$L$14:$L$18</c:f>
              <c:numCache>
                <c:formatCode>General</c:formatCode>
                <c:ptCount val="5"/>
                <c:pt idx="0">
                  <c:v>-0.369429393939394</c:v>
                </c:pt>
                <c:pt idx="1">
                  <c:v>-0.474096222222222</c:v>
                </c:pt>
                <c:pt idx="2">
                  <c:v>-0.218939090909091</c:v>
                </c:pt>
                <c:pt idx="3">
                  <c:v>-0.374781363636364</c:v>
                </c:pt>
                <c:pt idx="4">
                  <c:v>-0.2101794444444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1138648"/>
        <c:axId val="-2121150952"/>
      </c:barChart>
      <c:catAx>
        <c:axId val="-2101138648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21150952"/>
        <c:crosses val="autoZero"/>
        <c:auto val="1"/>
        <c:lblAlgn val="ctr"/>
        <c:lblOffset val="100"/>
        <c:noMultiLvlLbl val="0"/>
      </c:catAx>
      <c:valAx>
        <c:axId val="-21211509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011386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46251433063772"/>
          <c:y val="0.383077226342957"/>
          <c:w val="0.153748566936228"/>
          <c:h val="0.233845547314086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7155580444605"/>
          <c:y val="0.0756860336117504"/>
          <c:w val="0.590961576470833"/>
          <c:h val="0.6735043871310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BON_26Jun15!$K$25</c:f>
              <c:strCache>
                <c:ptCount val="1"/>
                <c:pt idx="0">
                  <c:v>LI</c:v>
                </c:pt>
              </c:strCache>
            </c:strRef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BON_26Jun15!$N$26:$N$33</c:f>
                <c:numCache>
                  <c:formatCode>General</c:formatCode>
                  <c:ptCount val="8"/>
                  <c:pt idx="0">
                    <c:v>0.0532141082786508</c:v>
                  </c:pt>
                  <c:pt idx="1">
                    <c:v>0.0604012744876986</c:v>
                  </c:pt>
                  <c:pt idx="2">
                    <c:v>0.0651605818924777</c:v>
                  </c:pt>
                  <c:pt idx="3">
                    <c:v>0.0452492475438182</c:v>
                  </c:pt>
                  <c:pt idx="4">
                    <c:v>0.0414591327808093</c:v>
                  </c:pt>
                  <c:pt idx="5">
                    <c:v>0.0754629051203373</c:v>
                  </c:pt>
                  <c:pt idx="6">
                    <c:v>0.0585829115793254</c:v>
                  </c:pt>
                  <c:pt idx="7">
                    <c:v>0.06782448230202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MBON_26Jun15!$J$26:$J$33</c:f>
              <c:strCache>
                <c:ptCount val="8"/>
                <c:pt idx="0">
                  <c:v>MB080C</c:v>
                </c:pt>
                <c:pt idx="1">
                  <c:v>MB052B</c:v>
                </c:pt>
                <c:pt idx="2">
                  <c:v>MB050B</c:v>
                </c:pt>
                <c:pt idx="3">
                  <c:v>MB542B</c:v>
                </c:pt>
                <c:pt idx="4">
                  <c:v>MB112C</c:v>
                </c:pt>
                <c:pt idx="5">
                  <c:v>MB298B</c:v>
                </c:pt>
                <c:pt idx="6">
                  <c:v>MB434B</c:v>
                </c:pt>
                <c:pt idx="7">
                  <c:v>MB433B</c:v>
                </c:pt>
              </c:strCache>
            </c:strRef>
          </c:cat>
          <c:val>
            <c:numRef>
              <c:f>MBON_26Jun15!$K$26:$K$33</c:f>
              <c:numCache>
                <c:formatCode>General</c:formatCode>
                <c:ptCount val="8"/>
                <c:pt idx="0">
                  <c:v>0.0761408333333333</c:v>
                </c:pt>
                <c:pt idx="1">
                  <c:v>0.2146545</c:v>
                </c:pt>
                <c:pt idx="2">
                  <c:v>0.0843367948717949</c:v>
                </c:pt>
                <c:pt idx="3">
                  <c:v>0.0754984848484848</c:v>
                </c:pt>
                <c:pt idx="4">
                  <c:v>0.155139895833333</c:v>
                </c:pt>
                <c:pt idx="5">
                  <c:v>0.121183529411765</c:v>
                </c:pt>
                <c:pt idx="6">
                  <c:v>0.0175221739130435</c:v>
                </c:pt>
                <c:pt idx="7">
                  <c:v>0.14782</c:v>
                </c:pt>
              </c:numCache>
            </c:numRef>
          </c:val>
        </c:ser>
        <c:ser>
          <c:idx val="1"/>
          <c:order val="1"/>
          <c:tx>
            <c:strRef>
              <c:f>MBON_26Jun15!$L$25</c:f>
              <c:strCache>
                <c:ptCount val="1"/>
                <c:pt idx="0">
                  <c:v>MI</c:v>
                </c:pt>
              </c:strCache>
            </c:strRef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MBON_26Jun15!$O$26:$O$33</c:f>
                <c:numCache>
                  <c:formatCode>General</c:formatCode>
                  <c:ptCount val="8"/>
                  <c:pt idx="0">
                    <c:v>0.128423396369546</c:v>
                  </c:pt>
                  <c:pt idx="1">
                    <c:v>0.0451095358010764</c:v>
                  </c:pt>
                  <c:pt idx="2">
                    <c:v>0.102570350086831</c:v>
                  </c:pt>
                  <c:pt idx="3">
                    <c:v>0.0965847654418352</c:v>
                  </c:pt>
                  <c:pt idx="4">
                    <c:v>0.0956510487643575</c:v>
                  </c:pt>
                  <c:pt idx="5">
                    <c:v>0.0713934544533458</c:v>
                  </c:pt>
                  <c:pt idx="6">
                    <c:v>0.0863405384214062</c:v>
                  </c:pt>
                  <c:pt idx="7">
                    <c:v>0.0906744910503353</c:v>
                  </c:pt>
                </c:numCache>
              </c:numRef>
            </c:minus>
          </c:errBars>
          <c:cat>
            <c:strRef>
              <c:f>MBON_26Jun15!$J$26:$J$33</c:f>
              <c:strCache>
                <c:ptCount val="8"/>
                <c:pt idx="0">
                  <c:v>MB080C</c:v>
                </c:pt>
                <c:pt idx="1">
                  <c:v>MB052B</c:v>
                </c:pt>
                <c:pt idx="2">
                  <c:v>MB050B</c:v>
                </c:pt>
                <c:pt idx="3">
                  <c:v>MB542B</c:v>
                </c:pt>
                <c:pt idx="4">
                  <c:v>MB112C</c:v>
                </c:pt>
                <c:pt idx="5">
                  <c:v>MB298B</c:v>
                </c:pt>
                <c:pt idx="6">
                  <c:v>MB434B</c:v>
                </c:pt>
                <c:pt idx="7">
                  <c:v>MB433B</c:v>
                </c:pt>
              </c:strCache>
            </c:strRef>
          </c:cat>
          <c:val>
            <c:numRef>
              <c:f>MBON_26Jun15!$L$26:$L$33</c:f>
              <c:numCache>
                <c:formatCode>General</c:formatCode>
                <c:ptCount val="8"/>
                <c:pt idx="0">
                  <c:v>-0.3490365</c:v>
                </c:pt>
                <c:pt idx="1">
                  <c:v>0.0150335</c:v>
                </c:pt>
                <c:pt idx="2">
                  <c:v>-0.0118710256410256</c:v>
                </c:pt>
                <c:pt idx="3">
                  <c:v>-0.105027121212121</c:v>
                </c:pt>
                <c:pt idx="4">
                  <c:v>-0.1423759375</c:v>
                </c:pt>
                <c:pt idx="5">
                  <c:v>-0.0410678431372549</c:v>
                </c:pt>
                <c:pt idx="6">
                  <c:v>-0.39422731884058</c:v>
                </c:pt>
                <c:pt idx="7">
                  <c:v>-0.06126880952380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6489800"/>
        <c:axId val="-2105146600"/>
      </c:barChart>
      <c:catAx>
        <c:axId val="-2116489800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05146600"/>
        <c:crosses val="autoZero"/>
        <c:auto val="1"/>
        <c:lblAlgn val="ctr"/>
        <c:lblOffset val="100"/>
        <c:noMultiLvlLbl val="0"/>
      </c:catAx>
      <c:valAx>
        <c:axId val="-2105146600"/>
        <c:scaling>
          <c:orientation val="minMax"/>
          <c:min val="-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648980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340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811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2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33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331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87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980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08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06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363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459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7" name="Table 4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0862666"/>
              </p:ext>
            </p:extLst>
          </p:nvPr>
        </p:nvGraphicFramePr>
        <p:xfrm>
          <a:off x="1463017" y="6583224"/>
          <a:ext cx="2201872" cy="1436080"/>
        </p:xfrm>
        <a:graphic>
          <a:graphicData uri="http://schemas.openxmlformats.org/drawingml/2006/table">
            <a:tbl>
              <a:tblPr/>
              <a:tblGrid>
                <a:gridCol w="275234"/>
                <a:gridCol w="275234"/>
                <a:gridCol w="275234"/>
                <a:gridCol w="275234"/>
                <a:gridCol w="275234"/>
                <a:gridCol w="275234"/>
                <a:gridCol w="275234"/>
                <a:gridCol w="275234"/>
              </a:tblGrid>
              <a:tr h="1002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002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002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002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002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002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002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</a:tr>
              <a:tr h="1002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870" marR="11870" marT="118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7924993"/>
              </p:ext>
            </p:extLst>
          </p:nvPr>
        </p:nvGraphicFramePr>
        <p:xfrm>
          <a:off x="587182" y="806460"/>
          <a:ext cx="1460206" cy="21813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0484798"/>
              </p:ext>
            </p:extLst>
          </p:nvPr>
        </p:nvGraphicFramePr>
        <p:xfrm>
          <a:off x="2170969" y="806460"/>
          <a:ext cx="1454306" cy="21813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584840"/>
              </p:ext>
            </p:extLst>
          </p:nvPr>
        </p:nvGraphicFramePr>
        <p:xfrm>
          <a:off x="3597124" y="806460"/>
          <a:ext cx="2561819" cy="21813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9160878"/>
              </p:ext>
            </p:extLst>
          </p:nvPr>
        </p:nvGraphicFramePr>
        <p:xfrm>
          <a:off x="597059" y="4395386"/>
          <a:ext cx="3760265" cy="21813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996740" y="560720"/>
            <a:ext cx="9115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/>
                <a:cs typeface="Arial"/>
              </a:rPr>
              <a:t>α’2 </a:t>
            </a:r>
            <a:r>
              <a:rPr lang="en-US" sz="1000" dirty="0">
                <a:latin typeface="Arial"/>
                <a:cs typeface="Arial"/>
              </a:rPr>
              <a:t>and </a:t>
            </a:r>
            <a:r>
              <a:rPr lang="en-US" sz="1000" dirty="0" smtClean="0">
                <a:latin typeface="Arial"/>
                <a:cs typeface="Arial"/>
              </a:rPr>
              <a:t>α</a:t>
            </a:r>
            <a:r>
              <a:rPr lang="en-US" sz="1000" dirty="0">
                <a:latin typeface="Arial"/>
                <a:cs typeface="Arial"/>
              </a:rPr>
              <a:t>3</a:t>
            </a:r>
            <a:endParaRPr lang="en-US" sz="1000" dirty="0" smtClean="0">
              <a:latin typeface="Arial"/>
              <a:cs typeface="Arial"/>
            </a:endParaRPr>
          </a:p>
          <a:p>
            <a:pPr algn="ctr"/>
            <a:r>
              <a:rPr lang="en-US" sz="1000" dirty="0" smtClean="0">
                <a:latin typeface="Arial"/>
                <a:cs typeface="Arial"/>
              </a:rPr>
              <a:t>MBON Lines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554929" y="560720"/>
            <a:ext cx="9115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/>
                <a:cs typeface="Arial"/>
              </a:rPr>
              <a:t>β2β’2a</a:t>
            </a:r>
          </a:p>
          <a:p>
            <a:pPr algn="ctr"/>
            <a:r>
              <a:rPr lang="en-US" sz="1000" dirty="0" smtClean="0">
                <a:latin typeface="Arial"/>
                <a:cs typeface="Arial"/>
              </a:rPr>
              <a:t>MBON Lines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375208" y="638730"/>
            <a:ext cx="12846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/>
                <a:cs typeface="Arial"/>
              </a:rPr>
              <a:t>Other</a:t>
            </a:r>
            <a:r>
              <a:rPr lang="en-US" sz="1000" dirty="0">
                <a:latin typeface="Arial"/>
                <a:cs typeface="Arial"/>
              </a:rPr>
              <a:t> </a:t>
            </a:r>
            <a:r>
              <a:rPr lang="en-US" sz="1000" dirty="0" smtClean="0">
                <a:latin typeface="Arial"/>
                <a:cs typeface="Arial"/>
              </a:rPr>
              <a:t>MBON Hits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832625" y="4284034"/>
            <a:ext cx="13779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/>
                <a:cs typeface="Arial"/>
              </a:rPr>
              <a:t>Other</a:t>
            </a:r>
            <a:r>
              <a:rPr lang="en-US" sz="1000" dirty="0">
                <a:latin typeface="Arial"/>
                <a:cs typeface="Arial"/>
              </a:rPr>
              <a:t> </a:t>
            </a:r>
            <a:r>
              <a:rPr lang="en-US" sz="1000" dirty="0" smtClean="0">
                <a:latin typeface="Arial"/>
                <a:cs typeface="Arial"/>
              </a:rPr>
              <a:t>MBON Lines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91795" y="56176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A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103759" y="560720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712189" y="560720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C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22942" y="4150686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D</a:t>
            </a:r>
          </a:p>
        </p:txBody>
      </p:sp>
      <p:graphicFrame>
        <p:nvGraphicFramePr>
          <p:cNvPr id="15" name="Tab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7006238"/>
              </p:ext>
            </p:extLst>
          </p:nvPr>
        </p:nvGraphicFramePr>
        <p:xfrm>
          <a:off x="1191330" y="2994298"/>
          <a:ext cx="529684" cy="391160"/>
        </p:xfrm>
        <a:graphic>
          <a:graphicData uri="http://schemas.openxmlformats.org/drawingml/2006/table">
            <a:tbl>
              <a:tblPr/>
              <a:tblGrid>
                <a:gridCol w="264842"/>
                <a:gridCol w="264842"/>
              </a:tblGrid>
              <a:tr h="1050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</a:tr>
              <a:tr h="1050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</a:tbl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909459" y="2973105"/>
            <a:ext cx="3238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α’2</a:t>
            </a:r>
            <a:endParaRPr lang="en-US" sz="800" dirty="0"/>
          </a:p>
        </p:txBody>
      </p:sp>
      <p:sp>
        <p:nvSpPr>
          <p:cNvPr id="18" name="TextBox 17"/>
          <p:cNvSpPr txBox="1"/>
          <p:nvPr/>
        </p:nvSpPr>
        <p:spPr>
          <a:xfrm>
            <a:off x="927731" y="3171190"/>
            <a:ext cx="3010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α3</a:t>
            </a:r>
            <a:endParaRPr lang="en-US" sz="800" dirty="0"/>
          </a:p>
        </p:txBody>
      </p:sp>
      <p:graphicFrame>
        <p:nvGraphicFramePr>
          <p:cNvPr id="19" name="Table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92842793"/>
              </p:ext>
            </p:extLst>
          </p:nvPr>
        </p:nvGraphicFramePr>
        <p:xfrm>
          <a:off x="2749336" y="2994298"/>
          <a:ext cx="521622" cy="586740"/>
        </p:xfrm>
        <a:graphic>
          <a:graphicData uri="http://schemas.openxmlformats.org/drawingml/2006/table">
            <a:tbl>
              <a:tblPr/>
              <a:tblGrid>
                <a:gridCol w="260811"/>
                <a:gridCol w="260811"/>
              </a:tblGrid>
              <a:tr h="1949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49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49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</a:tr>
            </a:tbl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2287781" y="2979165"/>
            <a:ext cx="48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γ2β’2a</a:t>
            </a:r>
            <a:endParaRPr lang="en-US" sz="800" dirty="0"/>
          </a:p>
        </p:txBody>
      </p:sp>
      <p:sp>
        <p:nvSpPr>
          <p:cNvPr id="21" name="TextBox 20"/>
          <p:cNvSpPr txBox="1"/>
          <p:nvPr/>
        </p:nvSpPr>
        <p:spPr>
          <a:xfrm>
            <a:off x="2306032" y="3179412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β’2mp </a:t>
            </a:r>
            <a:endParaRPr lang="en-US" sz="800" dirty="0"/>
          </a:p>
        </p:txBody>
      </p:sp>
      <p:sp>
        <p:nvSpPr>
          <p:cNvPr id="22" name="TextBox 21"/>
          <p:cNvSpPr txBox="1"/>
          <p:nvPr/>
        </p:nvSpPr>
        <p:spPr>
          <a:xfrm>
            <a:off x="2273898" y="3368360"/>
            <a:ext cx="4966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β2β’2a </a:t>
            </a:r>
            <a:endParaRPr lang="en-US" sz="800" dirty="0"/>
          </a:p>
        </p:txBody>
      </p:sp>
      <p:graphicFrame>
        <p:nvGraphicFramePr>
          <p:cNvPr id="24" name="Table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2369041"/>
              </p:ext>
            </p:extLst>
          </p:nvPr>
        </p:nvGraphicFramePr>
        <p:xfrm>
          <a:off x="4357324" y="2987840"/>
          <a:ext cx="1335285" cy="1173480"/>
        </p:xfrm>
        <a:graphic>
          <a:graphicData uri="http://schemas.openxmlformats.org/drawingml/2006/table">
            <a:tbl>
              <a:tblPr/>
              <a:tblGrid>
                <a:gridCol w="267057"/>
                <a:gridCol w="267057"/>
                <a:gridCol w="267057"/>
                <a:gridCol w="267057"/>
                <a:gridCol w="267057"/>
              </a:tblGrid>
              <a:tr h="1261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261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261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261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261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261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</a:tr>
            </a:tbl>
          </a:graphicData>
        </a:graphic>
      </p:graphicFrame>
      <p:sp>
        <p:nvSpPr>
          <p:cNvPr id="23" name="Rectangle 22"/>
          <p:cNvSpPr/>
          <p:nvPr/>
        </p:nvSpPr>
        <p:spPr>
          <a:xfrm>
            <a:off x="4362618" y="961870"/>
            <a:ext cx="256032" cy="3199450"/>
          </a:xfrm>
          <a:prstGeom prst="rect">
            <a:avLst/>
          </a:prstGeom>
          <a:noFill/>
          <a:ln w="19050">
            <a:solidFill>
              <a:srgbClr val="95373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4625538" y="961870"/>
            <a:ext cx="256032" cy="3199450"/>
          </a:xfrm>
          <a:prstGeom prst="rect">
            <a:avLst/>
          </a:prstGeom>
          <a:noFill/>
          <a:ln w="19050">
            <a:solidFill>
              <a:srgbClr val="95373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4895646" y="961870"/>
            <a:ext cx="256032" cy="3199450"/>
          </a:xfrm>
          <a:prstGeom prst="rect">
            <a:avLst/>
          </a:prstGeom>
          <a:noFill/>
          <a:ln w="19050">
            <a:solidFill>
              <a:srgbClr val="95373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5165754" y="961870"/>
            <a:ext cx="256032" cy="3199450"/>
          </a:xfrm>
          <a:prstGeom prst="rect">
            <a:avLst/>
          </a:prstGeom>
          <a:noFill/>
          <a:ln w="19050">
            <a:solidFill>
              <a:srgbClr val="95373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5435862" y="961870"/>
            <a:ext cx="256032" cy="3199450"/>
          </a:xfrm>
          <a:prstGeom prst="rect">
            <a:avLst/>
          </a:prstGeom>
          <a:noFill/>
          <a:ln w="19050">
            <a:solidFill>
              <a:srgbClr val="95373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035184" y="2979165"/>
            <a:ext cx="3235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β’1 </a:t>
            </a:r>
            <a:endParaRPr lang="en-US" sz="800" dirty="0"/>
          </a:p>
        </p:txBody>
      </p:sp>
      <p:sp>
        <p:nvSpPr>
          <p:cNvPr id="30" name="TextBox 29"/>
          <p:cNvSpPr txBox="1"/>
          <p:nvPr/>
        </p:nvSpPr>
        <p:spPr>
          <a:xfrm>
            <a:off x="3958329" y="3176679"/>
            <a:ext cx="403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α2sc</a:t>
            </a:r>
            <a:endParaRPr lang="en-US" sz="800" dirty="0"/>
          </a:p>
        </p:txBody>
      </p:sp>
      <p:sp>
        <p:nvSpPr>
          <p:cNvPr id="31" name="TextBox 30"/>
          <p:cNvSpPr txBox="1"/>
          <p:nvPr/>
        </p:nvSpPr>
        <p:spPr>
          <a:xfrm>
            <a:off x="3920081" y="3367059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α’3ap</a:t>
            </a:r>
            <a:endParaRPr lang="en-US" sz="800" dirty="0"/>
          </a:p>
        </p:txBody>
      </p:sp>
      <p:sp>
        <p:nvSpPr>
          <p:cNvPr id="32" name="TextBox 31"/>
          <p:cNvSpPr txBox="1"/>
          <p:nvPr/>
        </p:nvSpPr>
        <p:spPr>
          <a:xfrm>
            <a:off x="3947234" y="3562935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α’3m</a:t>
            </a:r>
            <a:endParaRPr lang="en-US" sz="800" dirty="0"/>
          </a:p>
        </p:txBody>
      </p:sp>
      <p:sp>
        <p:nvSpPr>
          <p:cNvPr id="33" name="TextBox 32"/>
          <p:cNvSpPr txBox="1"/>
          <p:nvPr/>
        </p:nvSpPr>
        <p:spPr>
          <a:xfrm>
            <a:off x="4034360" y="3756880"/>
            <a:ext cx="3238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α’1</a:t>
            </a:r>
            <a:endParaRPr lang="en-US" sz="800" dirty="0"/>
          </a:p>
        </p:txBody>
      </p:sp>
      <p:sp>
        <p:nvSpPr>
          <p:cNvPr id="34" name="TextBox 33"/>
          <p:cNvSpPr txBox="1"/>
          <p:nvPr/>
        </p:nvSpPr>
        <p:spPr>
          <a:xfrm>
            <a:off x="3943961" y="3951811"/>
            <a:ext cx="41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calyx</a:t>
            </a:r>
            <a:endParaRPr lang="en-US" sz="800" dirty="0"/>
          </a:p>
        </p:txBody>
      </p:sp>
      <p:sp>
        <p:nvSpPr>
          <p:cNvPr id="44" name="TextBox 43"/>
          <p:cNvSpPr txBox="1"/>
          <p:nvPr/>
        </p:nvSpPr>
        <p:spPr>
          <a:xfrm>
            <a:off x="1056104" y="6562708"/>
            <a:ext cx="403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α2sc</a:t>
            </a:r>
            <a:endParaRPr lang="en-US" sz="800" dirty="0"/>
          </a:p>
        </p:txBody>
      </p:sp>
      <p:sp>
        <p:nvSpPr>
          <p:cNvPr id="45" name="TextBox 44"/>
          <p:cNvSpPr txBox="1"/>
          <p:nvPr/>
        </p:nvSpPr>
        <p:spPr>
          <a:xfrm>
            <a:off x="980379" y="6740541"/>
            <a:ext cx="4796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α2p3p</a:t>
            </a:r>
            <a:endParaRPr lang="en-US" sz="800" dirty="0"/>
          </a:p>
        </p:txBody>
      </p:sp>
      <p:sp>
        <p:nvSpPr>
          <p:cNvPr id="46" name="TextBox 45"/>
          <p:cNvSpPr txBox="1"/>
          <p:nvPr/>
        </p:nvSpPr>
        <p:spPr>
          <a:xfrm>
            <a:off x="1135903" y="6918939"/>
            <a:ext cx="3238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α’1</a:t>
            </a:r>
            <a:endParaRPr lang="en-US" sz="800" dirty="0"/>
          </a:p>
        </p:txBody>
      </p:sp>
      <p:sp>
        <p:nvSpPr>
          <p:cNvPr id="48" name="TextBox 47"/>
          <p:cNvSpPr txBox="1"/>
          <p:nvPr/>
        </p:nvSpPr>
        <p:spPr>
          <a:xfrm>
            <a:off x="1016418" y="7102559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α’3ap</a:t>
            </a:r>
            <a:endParaRPr lang="en-US" sz="800" dirty="0"/>
          </a:p>
        </p:txBody>
      </p:sp>
      <p:sp>
        <p:nvSpPr>
          <p:cNvPr id="49" name="TextBox 48"/>
          <p:cNvSpPr txBox="1"/>
          <p:nvPr/>
        </p:nvSpPr>
        <p:spPr>
          <a:xfrm>
            <a:off x="1043571" y="7280957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α’3m</a:t>
            </a:r>
            <a:endParaRPr lang="en-US" sz="800" dirty="0"/>
          </a:p>
        </p:txBody>
      </p:sp>
      <p:sp>
        <p:nvSpPr>
          <p:cNvPr id="50" name="TextBox 49"/>
          <p:cNvSpPr txBox="1"/>
          <p:nvPr/>
        </p:nvSpPr>
        <p:spPr>
          <a:xfrm>
            <a:off x="749368" y="7461964"/>
            <a:ext cx="7489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γ1pedc&gt;</a:t>
            </a:r>
            <a:r>
              <a:rPr lang="en-US" sz="800" dirty="0" smtClean="0">
                <a:latin typeface="Arial"/>
                <a:cs typeface="Arial"/>
              </a:rPr>
              <a:t>α/β</a:t>
            </a:r>
            <a:endParaRPr lang="en-US" sz="800" dirty="0"/>
          </a:p>
        </p:txBody>
      </p:sp>
      <p:sp>
        <p:nvSpPr>
          <p:cNvPr id="51" name="TextBox 50"/>
          <p:cNvSpPr txBox="1"/>
          <p:nvPr/>
        </p:nvSpPr>
        <p:spPr>
          <a:xfrm>
            <a:off x="889645" y="7642524"/>
            <a:ext cx="5696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γ4&gt;γ1γ2</a:t>
            </a:r>
            <a:endParaRPr lang="en-US" sz="800" dirty="0"/>
          </a:p>
        </p:txBody>
      </p:sp>
      <p:sp>
        <p:nvSpPr>
          <p:cNvPr id="52" name="TextBox 51"/>
          <p:cNvSpPr txBox="1"/>
          <p:nvPr/>
        </p:nvSpPr>
        <p:spPr>
          <a:xfrm>
            <a:off x="1028471" y="7818577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β1&gt;</a:t>
            </a:r>
            <a:r>
              <a:rPr lang="en-US" sz="800" dirty="0">
                <a:latin typeface="Arial"/>
                <a:cs typeface="Arial"/>
              </a:rPr>
              <a:t>α</a:t>
            </a:r>
            <a:endParaRPr lang="en-US" sz="800" dirty="0"/>
          </a:p>
        </p:txBody>
      </p:sp>
      <p:sp>
        <p:nvSpPr>
          <p:cNvPr id="53" name="TextBox 52"/>
          <p:cNvSpPr txBox="1"/>
          <p:nvPr/>
        </p:nvSpPr>
        <p:spPr>
          <a:xfrm>
            <a:off x="1098044" y="1041434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375734" y="1102714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650015" y="953431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939095" y="934981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288376" y="929438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369513" y="1993035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635813" y="2128350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554676" y="1116008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826671" y="1097558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899341" y="1802373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091512" y="919261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5165641" y="1994638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352117" y="946371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431941" y="1782558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382758" y="4748175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462488" y="5612448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664642" y="4570417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942332" y="4728512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220022" y="4761317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497712" y="4668832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131448" y="5616930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329732" y="4646878"/>
            <a:ext cx="3245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01275" y="104976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igure S4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82830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0</Words>
  <Application>Microsoft Macintosh PowerPoint</Application>
  <PresentationFormat>Letter Paper (8.5x11 in)</PresentationFormat>
  <Paragraphs>16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lby Montague</dc:creator>
  <cp:lastModifiedBy>Shelby Montague</cp:lastModifiedBy>
  <cp:revision>3</cp:revision>
  <dcterms:created xsi:type="dcterms:W3CDTF">2016-09-29T23:23:19Z</dcterms:created>
  <dcterms:modified xsi:type="dcterms:W3CDTF">2016-09-29T23:24:30Z</dcterms:modified>
</cp:coreProperties>
</file>